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E195F4-B9DB-4AA2-BABB-CDFC4E448D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37995A-F15D-422B-90D1-9A1EAB48CE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9309BA-E1F5-40F4-B173-50EACD11267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A2D1F-F3E3-4B90-B20C-F3443651D3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EA5E1-610F-4105-8CE5-6671526575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8D7A4D-71F3-42ED-A7CC-55C0B88A89D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F4E6B9-2783-46AE-9167-AAD589AB77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E55AF-10A3-4A87-A091-01ECDD8A17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7271FD-2F1B-456F-B465-5F1AB9936E3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E41B72-B86B-461E-B64B-9B5881B37E7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99C11F-F347-4FA0-9C8F-A2D0A79FD3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2C6BA-FEEA-4AE1-9571-E975C0C100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CC25013-175B-4BBD-8535-28ABAD7E5EE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85920" y="1268640"/>
            <a:ext cx="8452800" cy="1009800"/>
            <a:chOff x="385920" y="1268640"/>
            <a:chExt cx="8452800" cy="1009800"/>
          </a:xfrm>
        </p:grpSpPr>
        <p:sp>
          <p:nvSpPr>
            <p:cNvPr id="42" name=""/>
            <p:cNvSpPr/>
            <p:nvPr/>
          </p:nvSpPr>
          <p:spPr>
            <a:xfrm rot="16200000">
              <a:off x="111240" y="1847160"/>
              <a:ext cx="701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Gastropo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rot="16200000">
              <a:off x="585000" y="1963080"/>
              <a:ext cx="450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Bivalv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 rot="16200000">
              <a:off x="913320" y="1926360"/>
              <a:ext cx="522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Anneli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rot="16200000">
              <a:off x="1232640" y="1892520"/>
              <a:ext cx="59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Crustace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 rot="16200000">
              <a:off x="1584000" y="1879920"/>
              <a:ext cx="60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Hexapo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rot="16200000">
              <a:off x="1967760" y="1888920"/>
              <a:ext cx="60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Priapuli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 rot="16200000">
              <a:off x="2300400" y="1873440"/>
              <a:ext cx="631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Mammali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rot="16200000">
              <a:off x="2568960" y="1759680"/>
              <a:ext cx="851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Hemichord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 rot="16200000">
              <a:off x="2890440" y="1745640"/>
              <a:ext cx="904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Echinoderm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6200000">
              <a:off x="3413160" y="1878480"/>
              <a:ext cx="57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Hydroz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 rot="16200000">
              <a:off x="3717720" y="1845720"/>
              <a:ext cx="706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Ctenophor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 rot="16200000">
              <a:off x="4164120" y="1908360"/>
              <a:ext cx="518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Cuboz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 rot="16200000">
              <a:off x="4467600" y="1845720"/>
              <a:ext cx="634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Scyphoz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 rot="16200000">
              <a:off x="4861080" y="1901160"/>
              <a:ext cx="566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Anthoz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 rot="16200000">
              <a:off x="5053320" y="1721880"/>
              <a:ext cx="906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Demospongia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rot="16200000">
              <a:off x="5451120" y="1749600"/>
              <a:ext cx="838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Hexactinellid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 rot="16200000">
              <a:off x="5976360" y="1919160"/>
              <a:ext cx="511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Calcare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 rot="16200000">
              <a:off x="6327000" y="1899360"/>
              <a:ext cx="524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Placoz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 rot="16200000">
              <a:off x="6444000" y="1697040"/>
              <a:ext cx="1009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Choanoflagell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 rot="16200000">
              <a:off x="6904800" y="1782720"/>
              <a:ext cx="838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Basidomyco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rot="16200000">
              <a:off x="7323120" y="1818720"/>
              <a:ext cx="717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Ascomyco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rot="16200000">
              <a:off x="7699680" y="1827360"/>
              <a:ext cx="70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Amoebozo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rot="16200000">
              <a:off x="7934400" y="1718640"/>
              <a:ext cx="941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Chromalveol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rot="16200000">
              <a:off x="8500680" y="1901880"/>
              <a:ext cx="523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Geneva"/>
                </a:rPr>
                <a:t>Excavat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6" name=""/>
          <p:cNvGrpSpPr/>
          <p:nvPr/>
        </p:nvGrpSpPr>
        <p:grpSpPr>
          <a:xfrm>
            <a:off x="457200" y="2324160"/>
            <a:ext cx="8305560" cy="4152240"/>
            <a:chOff x="457200" y="2324160"/>
            <a:chExt cx="8305560" cy="4152240"/>
          </a:xfrm>
        </p:grpSpPr>
        <p:sp>
          <p:nvSpPr>
            <p:cNvPr id="67" name=""/>
            <p:cNvSpPr/>
            <p:nvPr/>
          </p:nvSpPr>
          <p:spPr>
            <a:xfrm>
              <a:off x="457200" y="2324160"/>
              <a:ext cx="18036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8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37560" y="2324160"/>
              <a:ext cx="18000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0" y="160"/>
                  </a:moveTo>
                  <a:lnTo>
                    <a:pt x="80" y="112"/>
                  </a:lnTo>
                  <a:lnTo>
                    <a:pt x="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637560" y="2669760"/>
              <a:ext cx="270720" cy="345960"/>
            </a:xfrm>
            <a:custGeom>
              <a:avLst/>
              <a:gdLst/>
              <a:ahLst/>
              <a:rect l="l" t="t" r="r" b="b"/>
              <a:pathLst>
                <a:path w="120" h="160">
                  <a:moveTo>
                    <a:pt x="12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908280" y="2324160"/>
              <a:ext cx="270720" cy="691920"/>
            </a:xfrm>
            <a:custGeom>
              <a:avLst/>
              <a:gdLst/>
              <a:ahLst/>
              <a:rect l="l" t="t" r="r" b="b"/>
              <a:pathLst>
                <a:path w="120" h="320">
                  <a:moveTo>
                    <a:pt x="0" y="320"/>
                  </a:moveTo>
                  <a:lnTo>
                    <a:pt x="120" y="272"/>
                  </a:lnTo>
                  <a:lnTo>
                    <a:pt x="12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540440" y="2324160"/>
              <a:ext cx="18000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8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720800" y="2324160"/>
              <a:ext cx="18036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0" y="160"/>
                  </a:moveTo>
                  <a:lnTo>
                    <a:pt x="80" y="112"/>
                  </a:lnTo>
                  <a:lnTo>
                    <a:pt x="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720800" y="2669760"/>
              <a:ext cx="270720" cy="345960"/>
            </a:xfrm>
            <a:custGeom>
              <a:avLst/>
              <a:gdLst/>
              <a:ahLst/>
              <a:rect l="l" t="t" r="r" b="b"/>
              <a:pathLst>
                <a:path w="120" h="160">
                  <a:moveTo>
                    <a:pt x="12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991520" y="2324160"/>
              <a:ext cx="271080" cy="691920"/>
            </a:xfrm>
            <a:custGeom>
              <a:avLst/>
              <a:gdLst/>
              <a:ahLst/>
              <a:rect l="l" t="t" r="r" b="b"/>
              <a:pathLst>
                <a:path w="120" h="320">
                  <a:moveTo>
                    <a:pt x="0" y="320"/>
                  </a:moveTo>
                  <a:lnTo>
                    <a:pt x="120" y="272"/>
                  </a:lnTo>
                  <a:lnTo>
                    <a:pt x="12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908280" y="3016080"/>
              <a:ext cx="541440" cy="345960"/>
            </a:xfrm>
            <a:custGeom>
              <a:avLst/>
              <a:gdLst/>
              <a:ahLst/>
              <a:rect l="l" t="t" r="r" b="b"/>
              <a:pathLst>
                <a:path w="240" h="160">
                  <a:moveTo>
                    <a:pt x="24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450080" y="3016080"/>
              <a:ext cx="541440" cy="345960"/>
            </a:xfrm>
            <a:custGeom>
              <a:avLst/>
              <a:gdLst/>
              <a:ahLst/>
              <a:rect l="l" t="t" r="r" b="b"/>
              <a:pathLst>
                <a:path w="240" h="160">
                  <a:moveTo>
                    <a:pt x="0" y="160"/>
                  </a:moveTo>
                  <a:lnTo>
                    <a:pt x="240" y="112"/>
                  </a:lnTo>
                  <a:lnTo>
                    <a:pt x="24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984760" y="2324160"/>
              <a:ext cx="18036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8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165480" y="2324160"/>
              <a:ext cx="18000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0" y="160"/>
                  </a:moveTo>
                  <a:lnTo>
                    <a:pt x="80" y="112"/>
                  </a:lnTo>
                  <a:lnTo>
                    <a:pt x="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623680" y="2324160"/>
              <a:ext cx="270720" cy="691920"/>
            </a:xfrm>
            <a:custGeom>
              <a:avLst/>
              <a:gdLst/>
              <a:ahLst/>
              <a:rect l="l" t="t" r="r" b="b"/>
              <a:pathLst>
                <a:path w="120" h="320">
                  <a:moveTo>
                    <a:pt x="120" y="320"/>
                  </a:moveTo>
                  <a:lnTo>
                    <a:pt x="0" y="27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894400" y="2669760"/>
              <a:ext cx="271080" cy="345960"/>
            </a:xfrm>
            <a:custGeom>
              <a:avLst/>
              <a:gdLst/>
              <a:ahLst/>
              <a:rect l="l" t="t" r="r" b="b"/>
              <a:pathLst>
                <a:path w="120" h="160">
                  <a:moveTo>
                    <a:pt x="0" y="160"/>
                  </a:moveTo>
                  <a:lnTo>
                    <a:pt x="120" y="112"/>
                  </a:lnTo>
                  <a:lnTo>
                    <a:pt x="12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450080" y="3362400"/>
              <a:ext cx="722160" cy="345600"/>
            </a:xfrm>
            <a:custGeom>
              <a:avLst/>
              <a:gdLst/>
              <a:ahLst/>
              <a:rect l="l" t="t" r="r" b="b"/>
              <a:pathLst>
                <a:path w="320" h="160">
                  <a:moveTo>
                    <a:pt x="32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172240" y="3016080"/>
              <a:ext cx="722160" cy="691920"/>
            </a:xfrm>
            <a:custGeom>
              <a:avLst/>
              <a:gdLst/>
              <a:ahLst/>
              <a:rect l="l" t="t" r="r" b="b"/>
              <a:pathLst>
                <a:path w="320" h="320">
                  <a:moveTo>
                    <a:pt x="0" y="320"/>
                  </a:moveTo>
                  <a:lnTo>
                    <a:pt x="320" y="272"/>
                  </a:lnTo>
                  <a:lnTo>
                    <a:pt x="32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706920" y="2324160"/>
              <a:ext cx="18036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8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887640" y="2324160"/>
              <a:ext cx="18000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0" y="160"/>
                  </a:moveTo>
                  <a:lnTo>
                    <a:pt x="80" y="112"/>
                  </a:lnTo>
                  <a:lnTo>
                    <a:pt x="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429080" y="2324160"/>
              <a:ext cx="18036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8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609800" y="2324160"/>
              <a:ext cx="18036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0" y="160"/>
                  </a:moveTo>
                  <a:lnTo>
                    <a:pt x="80" y="112"/>
                  </a:lnTo>
                  <a:lnTo>
                    <a:pt x="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887640" y="2669760"/>
              <a:ext cx="360720" cy="345960"/>
            </a:xfrm>
            <a:custGeom>
              <a:avLst/>
              <a:gdLst/>
              <a:ahLst/>
              <a:rect l="l" t="t" r="r" b="b"/>
              <a:pathLst>
                <a:path w="160" h="160">
                  <a:moveTo>
                    <a:pt x="16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248720" y="2669760"/>
              <a:ext cx="361080" cy="345960"/>
            </a:xfrm>
            <a:custGeom>
              <a:avLst/>
              <a:gdLst/>
              <a:ahLst/>
              <a:rect l="l" t="t" r="r" b="b"/>
              <a:pathLst>
                <a:path w="160" h="160">
                  <a:moveTo>
                    <a:pt x="0" y="160"/>
                  </a:moveTo>
                  <a:lnTo>
                    <a:pt x="160" y="112"/>
                  </a:lnTo>
                  <a:lnTo>
                    <a:pt x="16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248720" y="3016080"/>
              <a:ext cx="451080" cy="345960"/>
            </a:xfrm>
            <a:custGeom>
              <a:avLst/>
              <a:gdLst/>
              <a:ahLst/>
              <a:rect l="l" t="t" r="r" b="b"/>
              <a:pathLst>
                <a:path w="200" h="160">
                  <a:moveTo>
                    <a:pt x="20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700160" y="2324160"/>
              <a:ext cx="451080" cy="1038240"/>
            </a:xfrm>
            <a:custGeom>
              <a:avLst/>
              <a:gdLst/>
              <a:ahLst/>
              <a:rect l="l" t="t" r="r" b="b"/>
              <a:pathLst>
                <a:path w="200" h="480">
                  <a:moveTo>
                    <a:pt x="0" y="480"/>
                  </a:moveTo>
                  <a:lnTo>
                    <a:pt x="200" y="432"/>
                  </a:lnTo>
                  <a:lnTo>
                    <a:pt x="20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5512680" y="2324160"/>
              <a:ext cx="18000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8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5693040" y="2324160"/>
              <a:ext cx="18036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0" y="160"/>
                  </a:moveTo>
                  <a:lnTo>
                    <a:pt x="80" y="112"/>
                  </a:lnTo>
                  <a:lnTo>
                    <a:pt x="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5693040" y="2669760"/>
              <a:ext cx="271080" cy="345960"/>
            </a:xfrm>
            <a:custGeom>
              <a:avLst/>
              <a:gdLst/>
              <a:ahLst/>
              <a:rect l="l" t="t" r="r" b="b"/>
              <a:pathLst>
                <a:path w="120" h="160">
                  <a:moveTo>
                    <a:pt x="12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964120" y="2324160"/>
              <a:ext cx="270720" cy="691920"/>
            </a:xfrm>
            <a:custGeom>
              <a:avLst/>
              <a:gdLst/>
              <a:ahLst/>
              <a:rect l="l" t="t" r="r" b="b"/>
              <a:pathLst>
                <a:path w="120" h="320">
                  <a:moveTo>
                    <a:pt x="0" y="320"/>
                  </a:moveTo>
                  <a:lnTo>
                    <a:pt x="120" y="272"/>
                  </a:lnTo>
                  <a:lnTo>
                    <a:pt x="12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700160" y="3362400"/>
              <a:ext cx="631800" cy="345600"/>
            </a:xfrm>
            <a:custGeom>
              <a:avLst/>
              <a:gdLst/>
              <a:ahLst/>
              <a:rect l="l" t="t" r="r" b="b"/>
              <a:pathLst>
                <a:path w="280" h="160">
                  <a:moveTo>
                    <a:pt x="28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331960" y="3016080"/>
              <a:ext cx="631800" cy="691920"/>
            </a:xfrm>
            <a:custGeom>
              <a:avLst/>
              <a:gdLst/>
              <a:ahLst/>
              <a:rect l="l" t="t" r="r" b="b"/>
              <a:pathLst>
                <a:path w="280" h="320">
                  <a:moveTo>
                    <a:pt x="0" y="320"/>
                  </a:moveTo>
                  <a:lnTo>
                    <a:pt x="280" y="272"/>
                  </a:lnTo>
                  <a:lnTo>
                    <a:pt x="2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331960" y="3708000"/>
              <a:ext cx="631800" cy="345960"/>
            </a:xfrm>
            <a:custGeom>
              <a:avLst/>
              <a:gdLst/>
              <a:ahLst/>
              <a:rect l="l" t="t" r="r" b="b"/>
              <a:pathLst>
                <a:path w="280" h="160">
                  <a:moveTo>
                    <a:pt x="28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5964120" y="2324160"/>
              <a:ext cx="631440" cy="1730160"/>
            </a:xfrm>
            <a:custGeom>
              <a:avLst/>
              <a:gdLst/>
              <a:ahLst/>
              <a:rect l="l" t="t" r="r" b="b"/>
              <a:pathLst>
                <a:path w="280" h="800">
                  <a:moveTo>
                    <a:pt x="0" y="800"/>
                  </a:moveTo>
                  <a:lnTo>
                    <a:pt x="280" y="752"/>
                  </a:lnTo>
                  <a:lnTo>
                    <a:pt x="2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172240" y="3708000"/>
              <a:ext cx="1895760" cy="691920"/>
            </a:xfrm>
            <a:custGeom>
              <a:avLst/>
              <a:gdLst/>
              <a:ahLst/>
              <a:rect l="l" t="t" r="r" b="b"/>
              <a:pathLst>
                <a:path w="840" h="320">
                  <a:moveTo>
                    <a:pt x="840" y="320"/>
                  </a:moveTo>
                  <a:lnTo>
                    <a:pt x="0" y="27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068000" y="4054320"/>
              <a:ext cx="1896120" cy="345600"/>
            </a:xfrm>
            <a:custGeom>
              <a:avLst/>
              <a:gdLst/>
              <a:ahLst/>
              <a:rect l="l" t="t" r="r" b="b"/>
              <a:pathLst>
                <a:path w="840" h="160">
                  <a:moveTo>
                    <a:pt x="0" y="160"/>
                  </a:moveTo>
                  <a:lnTo>
                    <a:pt x="840" y="112"/>
                  </a:lnTo>
                  <a:lnTo>
                    <a:pt x="84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068000" y="4400280"/>
              <a:ext cx="1444680" cy="345960"/>
            </a:xfrm>
            <a:custGeom>
              <a:avLst/>
              <a:gdLst/>
              <a:ahLst/>
              <a:rect l="l" t="t" r="r" b="b"/>
              <a:pathLst>
                <a:path w="640" h="160">
                  <a:moveTo>
                    <a:pt x="64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512680" y="2324160"/>
              <a:ext cx="1444320" cy="2422440"/>
            </a:xfrm>
            <a:custGeom>
              <a:avLst/>
              <a:gdLst/>
              <a:ahLst/>
              <a:rect l="l" t="t" r="r" b="b"/>
              <a:pathLst>
                <a:path w="640" h="1120">
                  <a:moveTo>
                    <a:pt x="0" y="1120"/>
                  </a:moveTo>
                  <a:lnTo>
                    <a:pt x="640" y="1072"/>
                  </a:lnTo>
                  <a:lnTo>
                    <a:pt x="64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7318080" y="2324160"/>
              <a:ext cx="18036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8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7498440" y="2324160"/>
              <a:ext cx="180360" cy="345600"/>
            </a:xfrm>
            <a:custGeom>
              <a:avLst/>
              <a:gdLst/>
              <a:ahLst/>
              <a:rect l="l" t="t" r="r" b="b"/>
              <a:pathLst>
                <a:path w="80" h="160">
                  <a:moveTo>
                    <a:pt x="0" y="160"/>
                  </a:moveTo>
                  <a:lnTo>
                    <a:pt x="80" y="112"/>
                  </a:lnTo>
                  <a:lnTo>
                    <a:pt x="8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512680" y="4746600"/>
              <a:ext cx="992880" cy="345600"/>
            </a:xfrm>
            <a:custGeom>
              <a:avLst/>
              <a:gdLst/>
              <a:ahLst/>
              <a:rect l="l" t="t" r="r" b="b"/>
              <a:pathLst>
                <a:path w="440" h="160">
                  <a:moveTo>
                    <a:pt x="440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6505560" y="2669760"/>
              <a:ext cx="992880" cy="2422440"/>
            </a:xfrm>
            <a:custGeom>
              <a:avLst/>
              <a:gdLst/>
              <a:ahLst/>
              <a:rect l="l" t="t" r="r" b="b"/>
              <a:pathLst>
                <a:path w="440" h="1120">
                  <a:moveTo>
                    <a:pt x="0" y="1120"/>
                  </a:moveTo>
                  <a:lnTo>
                    <a:pt x="440" y="1072"/>
                  </a:lnTo>
                  <a:lnTo>
                    <a:pt x="44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6505560" y="5092200"/>
              <a:ext cx="758160" cy="345960"/>
            </a:xfrm>
            <a:custGeom>
              <a:avLst/>
              <a:gdLst/>
              <a:ahLst/>
              <a:rect l="l" t="t" r="r" b="b"/>
              <a:pathLst>
                <a:path w="336" h="160">
                  <a:moveTo>
                    <a:pt x="336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7264080" y="2324160"/>
              <a:ext cx="776160" cy="3114360"/>
            </a:xfrm>
            <a:custGeom>
              <a:avLst/>
              <a:gdLst/>
              <a:ahLst/>
              <a:rect l="l" t="t" r="r" b="b"/>
              <a:pathLst>
                <a:path w="344" h="1440">
                  <a:moveTo>
                    <a:pt x="0" y="1440"/>
                  </a:moveTo>
                  <a:lnTo>
                    <a:pt x="344" y="1392"/>
                  </a:lnTo>
                  <a:lnTo>
                    <a:pt x="344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7264080" y="5438520"/>
              <a:ext cx="559080" cy="345600"/>
            </a:xfrm>
            <a:custGeom>
              <a:avLst/>
              <a:gdLst/>
              <a:ahLst/>
              <a:rect l="l" t="t" r="r" b="b"/>
              <a:pathLst>
                <a:path w="248" h="160">
                  <a:moveTo>
                    <a:pt x="248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7823520" y="2324160"/>
              <a:ext cx="577800" cy="3459960"/>
            </a:xfrm>
            <a:custGeom>
              <a:avLst/>
              <a:gdLst/>
              <a:ahLst/>
              <a:rect l="l" t="t" r="r" b="b"/>
              <a:pathLst>
                <a:path w="256" h="1600">
                  <a:moveTo>
                    <a:pt x="0" y="1600"/>
                  </a:moveTo>
                  <a:lnTo>
                    <a:pt x="256" y="1552"/>
                  </a:lnTo>
                  <a:lnTo>
                    <a:pt x="256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7823520" y="5784120"/>
              <a:ext cx="469080" cy="345960"/>
            </a:xfrm>
            <a:custGeom>
              <a:avLst/>
              <a:gdLst/>
              <a:ahLst/>
              <a:rect l="l" t="t" r="r" b="b"/>
              <a:pathLst>
                <a:path w="208" h="160">
                  <a:moveTo>
                    <a:pt x="208" y="160"/>
                  </a:moveTo>
                  <a:lnTo>
                    <a:pt x="0" y="112"/>
                  </a:lnTo>
                  <a:lnTo>
                    <a:pt x="0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8292960" y="2324160"/>
              <a:ext cx="469800" cy="3806280"/>
            </a:xfrm>
            <a:custGeom>
              <a:avLst/>
              <a:gdLst/>
              <a:ahLst/>
              <a:rect l="l" t="t" r="r" b="b"/>
              <a:pathLst>
                <a:path w="208" h="1760">
                  <a:moveTo>
                    <a:pt x="0" y="1760"/>
                  </a:moveTo>
                  <a:lnTo>
                    <a:pt x="208" y="1712"/>
                  </a:lnTo>
                  <a:lnTo>
                    <a:pt x="208" y="0"/>
                  </a:lnTo>
                </a:path>
              </a:pathLst>
            </a:custGeom>
            <a:noFill/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8292960" y="6130440"/>
              <a:ext cx="2520" cy="3459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4" name=""/>
          <p:cNvSpPr/>
          <p:nvPr/>
        </p:nvSpPr>
        <p:spPr>
          <a:xfrm>
            <a:off x="1631880" y="256536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720800" y="256536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886040" y="292104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974960" y="292104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067200" y="256536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3156120" y="256536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2787480" y="293364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2876400" y="2933640"/>
            <a:ext cx="95400" cy="139680"/>
          </a:xfrm>
          <a:prstGeom prst="rect">
            <a:avLst/>
          </a:prstGeom>
          <a:solidFill>
            <a:srgbClr val="e305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5594400" y="2577960"/>
            <a:ext cx="95040" cy="139680"/>
          </a:xfrm>
          <a:prstGeom prst="rect">
            <a:avLst/>
          </a:prstGeom>
          <a:solidFill>
            <a:srgbClr val="e305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5683320" y="257796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5873760" y="292104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5962680" y="292104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524480" y="256536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4613400" y="256536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3784680" y="256536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3873600" y="2565360"/>
            <a:ext cx="95040" cy="139680"/>
          </a:xfrm>
          <a:prstGeom prst="rect">
            <a:avLst/>
          </a:prstGeom>
          <a:solidFill>
            <a:srgbClr val="e305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4146480" y="2921040"/>
            <a:ext cx="95400" cy="139680"/>
          </a:xfrm>
          <a:prstGeom prst="rect">
            <a:avLst/>
          </a:prstGeom>
          <a:solidFill>
            <a:srgbClr val="e305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4235400" y="292104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610160" y="327672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4699080" y="3276720"/>
            <a:ext cx="95040" cy="139680"/>
          </a:xfrm>
          <a:prstGeom prst="rect">
            <a:avLst/>
          </a:prstGeom>
          <a:solidFill>
            <a:srgbClr val="e305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5238720" y="3632040"/>
            <a:ext cx="95400" cy="140040"/>
          </a:xfrm>
          <a:prstGeom prst="rect">
            <a:avLst/>
          </a:prstGeom>
          <a:solidFill>
            <a:srgbClr val="e305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5327640" y="3632040"/>
            <a:ext cx="95400" cy="14004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7397640" y="2577960"/>
            <a:ext cx="95400" cy="139680"/>
          </a:xfrm>
          <a:prstGeom prst="rect">
            <a:avLst/>
          </a:prstGeom>
          <a:solidFill>
            <a:srgbClr val="e305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7486560" y="257796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7169040" y="534672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7257960" y="534672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7728120" y="5702400"/>
            <a:ext cx="95040" cy="1396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7816680" y="570240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6419880" y="502920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6508800" y="502920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5416560" y="468648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5505480" y="468648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5873760" y="3987720"/>
            <a:ext cx="95400" cy="139680"/>
          </a:xfrm>
          <a:prstGeom prst="rect">
            <a:avLst/>
          </a:prstGeom>
          <a:solidFill>
            <a:srgbClr val="e305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5962680" y="398772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3968640" y="4317840"/>
            <a:ext cx="95400" cy="14004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4057560" y="4317840"/>
            <a:ext cx="95400" cy="1400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819000" y="292104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907920" y="292104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539640" y="254016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628560" y="254016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2076480" y="3645000"/>
            <a:ext cx="9540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2165400" y="3645000"/>
            <a:ext cx="95040" cy="1396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701720" y="5016600"/>
            <a:ext cx="228600" cy="3808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1930320" y="5016600"/>
            <a:ext cx="228600" cy="3808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1930320" y="5016600"/>
            <a:ext cx="228600" cy="380880"/>
          </a:xfrm>
          <a:prstGeom prst="rect">
            <a:avLst/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600200" y="5435640"/>
            <a:ext cx="228600" cy="380880"/>
          </a:xfrm>
          <a:prstGeom prst="rect">
            <a:avLst/>
          </a:prstGeom>
          <a:solidFill>
            <a:srgbClr val="16e321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2057400" y="5435640"/>
            <a:ext cx="228600" cy="380880"/>
          </a:xfrm>
          <a:prstGeom prst="rect">
            <a:avLst/>
          </a:prstGeom>
          <a:solidFill>
            <a:srgbClr val="e30528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828800" y="5435640"/>
            <a:ext cx="228600" cy="3808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4-28T19:06:08Z</dcterms:created>
  <dc:creator>Jesse Hernandez</dc:creator>
  <dc:description/>
  <dc:language>en-US</dc:language>
  <cp:lastModifiedBy>Bernd Schierwater</cp:lastModifiedBy>
  <cp:lastPrinted>2008-05-02T08:37:06Z</cp:lastPrinted>
  <dcterms:modified xsi:type="dcterms:W3CDTF">2008-12-04T12:27:41Z</dcterms:modified>
  <cp:revision>13</cp:revision>
  <dc:subject/>
  <dc:title>PowerPoint Presentation</dc:title>
</cp:coreProperties>
</file>